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0B0B0"/>
    <a:srgbClr val="FFCDFF"/>
    <a:srgbClr val="FFB9FF"/>
    <a:srgbClr val="FF99FF"/>
    <a:srgbClr val="FF99CC"/>
    <a:srgbClr val="3898B2"/>
    <a:srgbClr val="BF5B0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03" autoAdjust="0"/>
    <p:restoredTop sz="91610" autoAdjust="0"/>
  </p:normalViewPr>
  <p:slideViewPr>
    <p:cSldViewPr>
      <p:cViewPr varScale="1">
        <p:scale>
          <a:sx n="105" d="100"/>
          <a:sy n="105" d="100"/>
        </p:scale>
        <p:origin x="4404" y="13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DBDED3-28E7-429B-BE6C-4C03C60ABA58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C050B8-6C31-4B7F-8078-DA855FA915AE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702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Figure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C050B8-6C31-4B7F-8078-DA855FA915AE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9833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7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6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6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7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217388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3141488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4" y="2217388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4" y="3141488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94412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26E54-8D59-4D38-930E-E8EE1304F8F3}" type="datetimeFigureOut">
              <a:rPr lang="en-US" smtClean="0"/>
              <a:pPr/>
              <a:t>5/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1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8641E-A275-4724-AD7D-BDDEA3E7D859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16632" y="9129464"/>
            <a:ext cx="64087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tex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-specific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odin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omide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Shu and Hu, 1965) and (B)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il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 (Montoro et al., 2008). Latex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ifi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row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pear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own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68" y="272480"/>
            <a:ext cx="5695520" cy="3671006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68" y="3967238"/>
            <a:ext cx="5695520" cy="4905711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602968" y="34448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solidFill>
                  <a:schemeClr val="bg1"/>
                </a:solidFill>
              </a:rPr>
              <a:t>A</a:t>
            </a:r>
            <a:endParaRPr lang="fr-FR" dirty="0">
              <a:solidFill>
                <a:schemeClr val="bg1"/>
              </a:solidFill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554388" y="396113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276872" y="1424608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C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Connecteur droit avec flèche 7"/>
          <p:cNvCxnSpPr/>
          <p:nvPr/>
        </p:nvCxnSpPr>
        <p:spPr>
          <a:xfrm flipH="1">
            <a:off x="2132856" y="1680809"/>
            <a:ext cx="288032" cy="1078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cteur droit avec flèche 85"/>
          <p:cNvCxnSpPr/>
          <p:nvPr/>
        </p:nvCxnSpPr>
        <p:spPr>
          <a:xfrm flipH="1">
            <a:off x="2240868" y="1711985"/>
            <a:ext cx="180020" cy="2886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ZoneTexte 91"/>
          <p:cNvSpPr txBox="1"/>
          <p:nvPr/>
        </p:nvSpPr>
        <p:spPr>
          <a:xfrm>
            <a:off x="2276872" y="5313040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C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Connecteur droit avec flèche 92"/>
          <p:cNvCxnSpPr/>
          <p:nvPr/>
        </p:nvCxnSpPr>
        <p:spPr>
          <a:xfrm flipH="1">
            <a:off x="2132856" y="5569241"/>
            <a:ext cx="288032" cy="1078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Connecteur droit avec flèche 93"/>
          <p:cNvCxnSpPr/>
          <p:nvPr/>
        </p:nvCxnSpPr>
        <p:spPr>
          <a:xfrm>
            <a:off x="2420888" y="5600417"/>
            <a:ext cx="0" cy="27660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3</TotalTime>
  <Words>63</Words>
  <Application>Microsoft Office PowerPoint</Application>
  <PresentationFormat>Format A4 (210 x 297 mm)</PresentationFormat>
  <Paragraphs>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OSHIBA</dc:creator>
  <cp:lastModifiedBy>montoro</cp:lastModifiedBy>
  <cp:revision>112</cp:revision>
  <dcterms:created xsi:type="dcterms:W3CDTF">2016-06-06T02:01:04Z</dcterms:created>
  <dcterms:modified xsi:type="dcterms:W3CDTF">2017-05-03T08:45:39Z</dcterms:modified>
</cp:coreProperties>
</file>